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6F259-1168-4719-B654-B615E2E11C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41B46-8226-4CDF-B998-2063F876A9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F458F-7264-4CD1-96C6-7654BE3F11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7D422-B43C-4BE0-B0C2-A2DDB426C2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817E9-9D79-4081-9A26-CAFC2A9523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ACF65-1B5C-4CBC-BD35-EAF775CD6F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CC300-09D4-4273-8703-3A80668DB3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82283-CB6F-45B7-AD2C-EA6B7B9F9F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EFC1C-921C-4558-9D2A-4D508A9DF5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89855-C6D7-44AD-B981-5E213FC807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E4315-C64D-4E1A-9D03-EC2ED5888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E8D14-0EFC-45D6-B0B8-F801CB423A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326080"/>
            <a:ext cx="1598400" cy="63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080"/>
            <a:ext cx="2170080" cy="63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26080"/>
            <a:ext cx="1598400" cy="63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D0ACD515-C772-4B5C-9280-E0D3B33E0690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895480" y="771480"/>
            <a:ext cx="1384560" cy="2362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42" name=""/>
          <p:cNvGrpSpPr/>
          <p:nvPr/>
        </p:nvGrpSpPr>
        <p:grpSpPr>
          <a:xfrm>
            <a:off x="2209680" y="743040"/>
            <a:ext cx="642960" cy="1633680"/>
            <a:chOff x="2209680" y="743040"/>
            <a:chExt cx="642960" cy="1633680"/>
          </a:xfrm>
        </p:grpSpPr>
        <p:sp>
          <p:nvSpPr>
            <p:cNvPr id="43" name=""/>
            <p:cNvSpPr/>
            <p:nvPr/>
          </p:nvSpPr>
          <p:spPr>
            <a:xfrm>
              <a:off x="2614680" y="86364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624040" y="11304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24040" y="11970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624040" y="133020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624040" y="144468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614680" y="16351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614680" y="170172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614680" y="187308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614680" y="19591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614680" y="215892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614680" y="222552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214720" y="74304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262240" y="9842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262240" y="11016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262240" y="12254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214720" y="13302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43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214720" y="148752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8.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214720" y="159552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6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262240" y="17287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14720" y="18352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8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209680" y="20066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7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209680" y="21304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5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2895480" y="3317760"/>
            <a:ext cx="1387440" cy="2438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66" name=""/>
          <p:cNvGrpSpPr/>
          <p:nvPr/>
        </p:nvGrpSpPr>
        <p:grpSpPr>
          <a:xfrm>
            <a:off x="2176560" y="3276720"/>
            <a:ext cx="642960" cy="1633680"/>
            <a:chOff x="2176560" y="3276720"/>
            <a:chExt cx="642960" cy="1633680"/>
          </a:xfrm>
        </p:grpSpPr>
        <p:sp>
          <p:nvSpPr>
            <p:cNvPr id="67" name=""/>
            <p:cNvSpPr/>
            <p:nvPr/>
          </p:nvSpPr>
          <p:spPr>
            <a:xfrm>
              <a:off x="2581200" y="33973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590920" y="366408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590920" y="373068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590920" y="386388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590920" y="397836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581200" y="41688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581200" y="423540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581200" y="440676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581200" y="44928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581200" y="469260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581200" y="475920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181240" y="32767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228760" y="35179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228760" y="36352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228760" y="37591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81240" y="38638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43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181240" y="40212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8.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181240" y="41292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6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228760" y="42624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181240" y="436896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8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176560" y="454032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7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176560" y="466416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5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9" name="" descr=""/>
          <p:cNvPicPr/>
          <p:nvPr/>
        </p:nvPicPr>
        <p:blipFill>
          <a:blip r:embed="rId3"/>
          <a:srcRect l="53502" t="14860" r="32010" b="22724"/>
          <a:stretch/>
        </p:blipFill>
        <p:spPr>
          <a:xfrm>
            <a:off x="3029040" y="6095880"/>
            <a:ext cx="1143000" cy="2457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90" name=""/>
          <p:cNvGrpSpPr/>
          <p:nvPr/>
        </p:nvGrpSpPr>
        <p:grpSpPr>
          <a:xfrm>
            <a:off x="2328840" y="6083280"/>
            <a:ext cx="642960" cy="1633680"/>
            <a:chOff x="2328840" y="6083280"/>
            <a:chExt cx="642960" cy="1633680"/>
          </a:xfrm>
        </p:grpSpPr>
        <p:sp>
          <p:nvSpPr>
            <p:cNvPr id="91" name=""/>
            <p:cNvSpPr/>
            <p:nvPr/>
          </p:nvSpPr>
          <p:spPr>
            <a:xfrm>
              <a:off x="2733840" y="620388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743200" y="647064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743200" y="653724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743200" y="66708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743200" y="678492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733840" y="6975360"/>
              <a:ext cx="2286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733840" y="70423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733840" y="721368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733840" y="729936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733840" y="74995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733840" y="756612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333520" y="60832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381400" y="63244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381400" y="644220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381400" y="656604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333520" y="667080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43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333520" y="682776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8.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333520" y="693576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6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381400" y="706896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333520" y="71755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8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328840" y="734688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7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328840" y="74707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PH" sz="1000" spc="-1" strike="noStrike">
                  <a:solidFill>
                    <a:srgbClr val="000000"/>
                  </a:solidFill>
                  <a:latin typeface="Arial"/>
                </a:rPr>
                <a:t>25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3" name=""/>
          <p:cNvSpPr/>
          <p:nvPr/>
        </p:nvSpPr>
        <p:spPr>
          <a:xfrm>
            <a:off x="2892600" y="50652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914560" y="503280"/>
            <a:ext cx="124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lFE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457440" y="507960"/>
            <a:ext cx="124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lFER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809800" y="507960"/>
            <a:ext cx="167652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895480" y="228600"/>
            <a:ext cx="15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imary Antibod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648320" y="2039760"/>
            <a:ext cx="12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rHlFE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4341600" y="2181240"/>
            <a:ext cx="307800" cy="14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648320" y="4487760"/>
            <a:ext cx="12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rHlFER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4341600" y="4629240"/>
            <a:ext cx="307800" cy="1440"/>
          </a:xfrm>
          <a:prstGeom prst="line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943360" y="586728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Arial"/>
              </a:rPr>
              <a:t>rHlFE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524400" y="586728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Arial"/>
              </a:rPr>
              <a:t>rHlFER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752480" y="38088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600200" y="594360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066680" y="7238880"/>
            <a:ext cx="129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Secondary antibody on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80880" y="8458200"/>
            <a:ext cx="426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Arial"/>
              </a:rPr>
              <a:t>Galay et al,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26T11:02:24Z</dcterms:created>
  <dc:creator>doc rem</dc:creator>
  <dc:description/>
  <dc:language>en-US</dc:language>
  <cp:lastModifiedBy>doc rem</cp:lastModifiedBy>
  <dcterms:modified xsi:type="dcterms:W3CDTF">2014-08-26T11:33:26Z</dcterms:modified>
  <cp:revision>2</cp:revision>
  <dc:subject/>
  <dc:title>Slide 1</dc:title>
</cp:coreProperties>
</file>